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8E6EA-F162-4450-A6BB-F032BFA291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BB4F7-2C51-414A-9A2F-BED62A0CEA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5F78E-DD44-4FD4-A047-A7599B17F4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5369E-56E5-4158-8DFC-5B681B5683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4AE2C-1DE4-4D82-828C-B75164F025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42B36-C52B-44FD-BF58-CFEF6C15DD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DBB74-195D-4181-ACCD-8AC8ABC82D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E681E-6A40-4858-9BD2-B6234A3E9F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CDA92-054F-4ADC-B475-2CA86025D7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9DC70-6D44-424B-9F9E-6B80565174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8C98F-2584-4EEF-989A-F674C2288B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65D16-C3AA-4EE7-B14E-EEC08FC52F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7D699C-CB09-41F2-995D-37E65F50E6B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271160" y="1913760"/>
            <a:ext cx="4397760" cy="1361520"/>
            <a:chOff x="1271160" y="1913760"/>
            <a:chExt cx="4397760" cy="1361520"/>
          </a:xfrm>
        </p:grpSpPr>
        <p:sp>
          <p:nvSpPr>
            <p:cNvPr id="42" name=""/>
            <p:cNvSpPr/>
            <p:nvPr/>
          </p:nvSpPr>
          <p:spPr>
            <a:xfrm rot="18220800">
              <a:off x="3185280" y="2223000"/>
              <a:ext cx="842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D1+TNF-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α</a:t>
              </a: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rot="18220800">
              <a:off x="4019400" y="2211120"/>
              <a:ext cx="86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D6+TNF-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α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4" name=""/>
            <p:cNvGraphicFramePr/>
            <p:nvPr/>
          </p:nvGraphicFramePr>
          <p:xfrm>
            <a:off x="1882800" y="2678040"/>
            <a:ext cx="2879640" cy="2286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882800" y="2678040"/>
                      <a:ext cx="2879640" cy="228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6" name=""/>
            <p:cNvGraphicFramePr/>
            <p:nvPr/>
          </p:nvGraphicFramePr>
          <p:xfrm>
            <a:off x="1881360" y="3046320"/>
            <a:ext cx="2879640" cy="2206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881360" y="3046320"/>
                      <a:ext cx="2879640" cy="2206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" name=""/>
            <p:cNvSpPr/>
            <p:nvPr/>
          </p:nvSpPr>
          <p:spPr>
            <a:xfrm rot="18220800">
              <a:off x="1888200" y="2388600"/>
              <a:ext cx="50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T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8220800">
              <a:off x="2138040" y="2338920"/>
              <a:ext cx="563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TNF-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α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8220800">
              <a:off x="2469240" y="2409840"/>
              <a:ext cx="44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X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8220800">
              <a:off x="3024720" y="2404440"/>
              <a:ext cx="46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8220800">
              <a:off x="3537000" y="2311200"/>
              <a:ext cx="69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1+DX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8220800">
              <a:off x="3839040" y="2404440"/>
              <a:ext cx="46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8220800">
              <a:off x="4361760" y="2304360"/>
              <a:ext cx="69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6+DX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747160" y="251604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W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984920" y="3035160"/>
              <a:ext cx="684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65 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808520" y="3136680"/>
              <a:ext cx="236520" cy="38160"/>
            </a:xfrm>
            <a:custGeom>
              <a:avLst/>
              <a:gdLst/>
              <a:ahLst/>
              <a:rect l="l" t="t" r="r" b="b"/>
              <a:pathLst>
                <a:path w="126" h="48">
                  <a:moveTo>
                    <a:pt x="123" y="27"/>
                  </a:moveTo>
                  <a:lnTo>
                    <a:pt x="40" y="27"/>
                  </a:lnTo>
                  <a:lnTo>
                    <a:pt x="40" y="27"/>
                  </a:lnTo>
                  <a:lnTo>
                    <a:pt x="38" y="27"/>
                  </a:lnTo>
                  <a:lnTo>
                    <a:pt x="38" y="25"/>
                  </a:lnTo>
                  <a:lnTo>
                    <a:pt x="38" y="25"/>
                  </a:lnTo>
                  <a:lnTo>
                    <a:pt x="38" y="23"/>
                  </a:lnTo>
                  <a:lnTo>
                    <a:pt x="38" y="21"/>
                  </a:lnTo>
                  <a:lnTo>
                    <a:pt x="40" y="21"/>
                  </a:lnTo>
                  <a:lnTo>
                    <a:pt x="40" y="21"/>
                  </a:lnTo>
                  <a:lnTo>
                    <a:pt x="123" y="21"/>
                  </a:lnTo>
                  <a:lnTo>
                    <a:pt x="125" y="21"/>
                  </a:lnTo>
                  <a:lnTo>
                    <a:pt x="126" y="21"/>
                  </a:lnTo>
                  <a:lnTo>
                    <a:pt x="126" y="23"/>
                  </a:lnTo>
                  <a:lnTo>
                    <a:pt x="126" y="25"/>
                  </a:lnTo>
                  <a:lnTo>
                    <a:pt x="126" y="25"/>
                  </a:lnTo>
                  <a:lnTo>
                    <a:pt x="126" y="27"/>
                  </a:lnTo>
                  <a:lnTo>
                    <a:pt x="125" y="27"/>
                  </a:lnTo>
                  <a:lnTo>
                    <a:pt x="123" y="27"/>
                  </a:lnTo>
                  <a:lnTo>
                    <a:pt x="123" y="27"/>
                  </a:lnTo>
                  <a:close/>
                  <a:moveTo>
                    <a:pt x="48" y="48"/>
                  </a:moveTo>
                  <a:lnTo>
                    <a:pt x="0" y="25"/>
                  </a:lnTo>
                  <a:lnTo>
                    <a:pt x="48" y="0"/>
                  </a:lnTo>
                  <a:lnTo>
                    <a:pt x="48" y="48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271160" y="3029040"/>
              <a:ext cx="58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AM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335240" y="2671560"/>
              <a:ext cx="57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NF-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976640" y="2652840"/>
              <a:ext cx="636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Arial"/>
                </a:rPr>
                <a:t>65 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797360" y="2754360"/>
              <a:ext cx="236520" cy="38160"/>
            </a:xfrm>
            <a:custGeom>
              <a:avLst/>
              <a:gdLst/>
              <a:ahLst/>
              <a:rect l="l" t="t" r="r" b="b"/>
              <a:pathLst>
                <a:path w="126" h="48">
                  <a:moveTo>
                    <a:pt x="123" y="27"/>
                  </a:moveTo>
                  <a:lnTo>
                    <a:pt x="40" y="27"/>
                  </a:lnTo>
                  <a:lnTo>
                    <a:pt x="40" y="27"/>
                  </a:lnTo>
                  <a:lnTo>
                    <a:pt x="38" y="27"/>
                  </a:lnTo>
                  <a:lnTo>
                    <a:pt x="38" y="25"/>
                  </a:lnTo>
                  <a:lnTo>
                    <a:pt x="38" y="25"/>
                  </a:lnTo>
                  <a:lnTo>
                    <a:pt x="38" y="23"/>
                  </a:lnTo>
                  <a:lnTo>
                    <a:pt x="38" y="21"/>
                  </a:lnTo>
                  <a:lnTo>
                    <a:pt x="40" y="21"/>
                  </a:lnTo>
                  <a:lnTo>
                    <a:pt x="40" y="21"/>
                  </a:lnTo>
                  <a:lnTo>
                    <a:pt x="123" y="21"/>
                  </a:lnTo>
                  <a:lnTo>
                    <a:pt x="125" y="21"/>
                  </a:lnTo>
                  <a:lnTo>
                    <a:pt x="126" y="21"/>
                  </a:lnTo>
                  <a:lnTo>
                    <a:pt x="126" y="23"/>
                  </a:lnTo>
                  <a:lnTo>
                    <a:pt x="126" y="25"/>
                  </a:lnTo>
                  <a:lnTo>
                    <a:pt x="126" y="25"/>
                  </a:lnTo>
                  <a:lnTo>
                    <a:pt x="126" y="27"/>
                  </a:lnTo>
                  <a:lnTo>
                    <a:pt x="125" y="27"/>
                  </a:lnTo>
                  <a:lnTo>
                    <a:pt x="123" y="27"/>
                  </a:lnTo>
                  <a:lnTo>
                    <a:pt x="123" y="27"/>
                  </a:lnTo>
                  <a:close/>
                  <a:moveTo>
                    <a:pt x="48" y="48"/>
                  </a:moveTo>
                  <a:lnTo>
                    <a:pt x="0" y="25"/>
                  </a:lnTo>
                  <a:lnTo>
                    <a:pt x="48" y="0"/>
                  </a:lnTo>
                  <a:lnTo>
                    <a:pt x="48" y="48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"/>
          <p:cNvSpPr/>
          <p:nvPr/>
        </p:nvSpPr>
        <p:spPr>
          <a:xfrm>
            <a:off x="595440" y="4145040"/>
            <a:ext cx="5667120" cy="335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Legen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ffects of D1 and D6 on NFkB expression in neuroblastoma cells after treatments with either TN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or Doxorubicin. SH-SY5Y were untreated (CTR) or treated with 3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 of both D1 and D6 for 24 hours. Six hours before the end of the treatment, either 25 ng/ml TN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or 2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/ml Doxorubicin (DXR) were added to the D1/D6 treated cells. Nuclear cellular fractions were processed by western blot analysis. Blot is representative of three independent experiments and data are normalized against Lamin A/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Method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human neuroblastoma cell line, SH-SY5Y, was grown in DMEM (Sigma). The cells were plated in 100 mm petri dishes, cultured for 24 hours and then untreated or treated with 3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 of either D1 or D6 for 24 hours. Six hours before the end of the treatment, 25 ng/ml of TN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recombinant human TNF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, Strathmann-Biotec AG, Hamburg, Germany) or 2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/ml of Doxorubicin (Sigma) respectively, were added to the dishes. Nuclear cellular fractions were obtained and then processed by western blot analysis, as described in Material and Method. Lamin A/C was used as loading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00120" y="1166760"/>
            <a:ext cx="500364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3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ffects of D1 and D6 on NFkB expression in neuroblastoma cell lin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8T14:33:56Z</dcterms:created>
  <dc:creator>DANY</dc:creator>
  <dc:description/>
  <dc:language>en-US</dc:language>
  <cp:lastModifiedBy>C.N.R</cp:lastModifiedBy>
  <dcterms:modified xsi:type="dcterms:W3CDTF">2010-05-28T15:23:22Z</dcterms:modified>
  <cp:revision>17</cp:revision>
  <dc:subject/>
  <dc:title>Diapositiva 1</dc:title>
</cp:coreProperties>
</file>